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5" autoAdjust="0"/>
    <p:restoredTop sz="76382" autoAdjust="0"/>
  </p:normalViewPr>
  <p:slideViewPr>
    <p:cSldViewPr>
      <p:cViewPr>
        <p:scale>
          <a:sx n="100" d="100"/>
          <a:sy n="100" d="100"/>
        </p:scale>
        <p:origin x="-1140" y="16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Relationship Id="rId9" Type="http://schemas.openxmlformats.org/officeDocument/2006/relationships/image" Target="../media/image8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1100703"/>
            <a:ext cx="1422400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52600" y="1064191"/>
            <a:ext cx="1427163" cy="1427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18098" y="1100703"/>
            <a:ext cx="1422400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10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98182" y="1100703"/>
            <a:ext cx="1427162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1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8600" y="3157359"/>
            <a:ext cx="1422400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1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752600" y="3157359"/>
            <a:ext cx="1427163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1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518098" y="3157359"/>
            <a:ext cx="1422400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20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085184" y="3157359"/>
            <a:ext cx="1382712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CasellaDiTesto 9"/>
          <p:cNvSpPr txBox="1"/>
          <p:nvPr/>
        </p:nvSpPr>
        <p:spPr>
          <a:xfrm>
            <a:off x="2708920" y="1115616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u="none" dirty="0" smtClean="0">
                <a:latin typeface="Arial" charset="0"/>
                <a:ea typeface="Arial" charset="0"/>
                <a:cs typeface="Arial" charset="0"/>
              </a:rPr>
              <a:t>IL-7R</a:t>
            </a:r>
            <a:r>
              <a:rPr lang="it-IT" sz="800" u="none" baseline="30000" dirty="0" smtClean="0">
                <a:latin typeface="Arial" charset="0"/>
                <a:ea typeface="Arial" charset="0"/>
                <a:cs typeface="Arial" charset="0"/>
              </a:rPr>
              <a:t>pos</a:t>
            </a:r>
            <a:endParaRPr lang="it-IT" sz="800" u="none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1988840" y="1115616"/>
            <a:ext cx="5629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u="none" smtClean="0">
                <a:latin typeface="Arial" charset="0"/>
                <a:ea typeface="Arial" charset="0"/>
                <a:cs typeface="Arial" charset="0"/>
              </a:rPr>
              <a:t>IL-7R</a:t>
            </a:r>
            <a:r>
              <a:rPr lang="it-IT" sz="800" baseline="30000" smtClean="0">
                <a:latin typeface="Arial" charset="0"/>
                <a:ea typeface="Arial" charset="0"/>
                <a:cs typeface="Arial" charset="0"/>
              </a:rPr>
              <a:t>neg</a:t>
            </a:r>
            <a:endParaRPr lang="it-IT" sz="800" u="none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2243502" y="755576"/>
            <a:ext cx="22669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1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month</a:t>
            </a:r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after</a:t>
            </a:r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 HCMV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infection</a:t>
            </a:r>
            <a:endParaRPr lang="it-IT" sz="1200" u="none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2243502" y="2771800"/>
            <a:ext cx="2409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12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months</a:t>
            </a:r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after</a:t>
            </a:r>
            <a:r>
              <a:rPr lang="it-IT" sz="1200" u="none" dirty="0" smtClean="0">
                <a:latin typeface="Arial" charset="0"/>
                <a:ea typeface="Arial" charset="0"/>
                <a:cs typeface="Arial" charset="0"/>
              </a:rPr>
              <a:t> HCMV </a:t>
            </a:r>
            <a:r>
              <a:rPr lang="it-IT" sz="1200" u="none" dirty="0" err="1" smtClean="0">
                <a:latin typeface="Arial" charset="0"/>
                <a:ea typeface="Arial" charset="0"/>
                <a:cs typeface="Arial" charset="0"/>
              </a:rPr>
              <a:t>infection</a:t>
            </a:r>
            <a:endParaRPr lang="it-IT" sz="1200" u="none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116632" y="5076056"/>
            <a:ext cx="1364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charset="0"/>
                <a:ea typeface="Arial" charset="0"/>
                <a:cs typeface="Arial" charset="0"/>
              </a:rPr>
              <a:t>Figure S2 </a:t>
            </a:r>
            <a:endParaRPr lang="it-IT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1484784" y="683568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it-IT" sz="16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1484784" y="269979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it-IT" sz="16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4796626" y="683568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it-IT" sz="16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" name="CasellaDiTesto 32"/>
          <p:cNvSpPr txBox="1"/>
          <p:nvPr/>
        </p:nvSpPr>
        <p:spPr>
          <a:xfrm>
            <a:off x="4796626" y="269979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it-IT" sz="16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0" y="6835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lang="it-IT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0" y="26997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it-IT" b="1" dirty="0">
              <a:latin typeface="Arial" charset="0"/>
              <a:ea typeface="Arial" charset="0"/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81</TotalTime>
  <Words>24</Words>
  <Application>Microsoft Office PowerPoint</Application>
  <PresentationFormat>Presentazione su schermo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erna</dc:creator>
  <cp:lastModifiedBy>gerna</cp:lastModifiedBy>
  <cp:revision>85</cp:revision>
  <dcterms:created xsi:type="dcterms:W3CDTF">2016-04-12T10:09:14Z</dcterms:created>
  <dcterms:modified xsi:type="dcterms:W3CDTF">2017-06-12T14:37:24Z</dcterms:modified>
</cp:coreProperties>
</file>